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4" r:id="rId2"/>
  </p:sldIdLst>
  <p:sldSz cx="6858000" cy="9144000" type="screen4x3"/>
  <p:notesSz cx="6858000" cy="9144000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64" autoAdjust="0"/>
    <p:restoredTop sz="96327" autoAdjust="0"/>
  </p:normalViewPr>
  <p:slideViewPr>
    <p:cSldViewPr>
      <p:cViewPr varScale="1">
        <p:scale>
          <a:sx n="92" d="100"/>
          <a:sy n="92" d="100"/>
        </p:scale>
        <p:origin x="2712" y="1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960F77E1-7C71-CBF5-705E-9185789B2519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4A04E50-1894-B44D-ABDD-3682806C348A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</a:lstStyle>
          <a:p>
            <a:pPr>
              <a:defRPr/>
            </a:pPr>
            <a:fld id="{8AB0B86A-7B69-5D44-BA55-41B2EF7278F4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D45E8AA-3047-E303-D4FB-CAC889985118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9770A2F-CB03-56AC-06B3-81936622D7D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游ゴシック" panose="020B0400000000000000" pitchFamily="34" charset="-128"/>
                <a:ea typeface="游ゴシック" panose="020B0400000000000000" pitchFamily="34" charset="-128"/>
              </a:defRPr>
            </a:lvl1pPr>
          </a:lstStyle>
          <a:p>
            <a:pPr>
              <a:defRPr/>
            </a:pPr>
            <a:fld id="{D6F13978-D441-CF45-841E-17899F85C0B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95797045-37C8-F12C-AA8B-79DF7B3E701F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60C44E2-5899-A0AB-C1AD-81A672523079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73750B33-6436-C143-A852-68D6C355DFF1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4" name="スライド イメージ プレースホルダー 3">
            <a:extLst>
              <a:ext uri="{FF2B5EF4-FFF2-40B4-BE49-F238E27FC236}">
                <a16:creationId xmlns:a16="http://schemas.microsoft.com/office/drawing/2014/main" id="{C44DE7B5-6584-C5C4-F8C4-4A04023A1F66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>
            <a:extLst>
              <a:ext uri="{FF2B5EF4-FFF2-40B4-BE49-F238E27FC236}">
                <a16:creationId xmlns:a16="http://schemas.microsoft.com/office/drawing/2014/main" id="{1B478469-6905-9826-4A5A-EA5C57388C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/>
              <a:t>マスター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B076359-11DA-FCE1-7549-1B4C1889BE69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6045BC8-EE7A-FE18-83C6-57AAA61022C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FDC1275B-F4B2-C54E-9C45-E7E5F5A10F4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anose="020B0600070205080204" pitchFamily="34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anose="020B0600070205080204" pitchFamily="34" charset="-128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anose="020B0600070205080204" pitchFamily="34" charset="-128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anose="020B0600070205080204" pitchFamily="34" charset="-128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anose="020B0600070205080204" pitchFamily="34" charset="-128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1772C0D4-A057-664A-DDC5-6893AD495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C663AD-2C2B-944C-8310-7EEDDDB38D39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D8EE280A-3AF0-DDC6-6E3E-F9BC6CB4D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E8C9C247-E3A4-116C-BCCB-C6DE271C5D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E83FAB-813C-EB45-8C97-E48C842C266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61785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9EE9A12E-97FF-22BE-C0F3-83D3DC355A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3BB733-1B0C-7F46-9E15-8AD2E70633F8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249FE0F6-7BF9-F1F0-8958-B90BE669F1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1D891450-02B6-4385-CCE1-FE92E9ACC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CBACA7-131B-9442-B6E1-9FC5B18238B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9733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D0406D22-1C78-D219-707A-0649836DF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E455E5-A29F-6347-826E-CDE7B95A4735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8E7DA368-D2A9-344C-6C41-4E929FCDB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7E8FBF98-2236-05C8-37EF-4D05CB4C9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45F38B-AFA0-5144-ADC3-3E1168C731D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45491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01D381D3-8B5A-E946-E7A9-9BCFBF141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A26283-F727-DC48-BA0A-E137BDD77B18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AD49BC11-501C-195E-49BA-E31D706A2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7DD018A0-E5D6-267E-06EA-608A21042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3002E2-C3CF-2C40-9D7D-1EBE72C388C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10224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9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8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8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7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7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6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5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63663A5D-D686-5BCA-E3B3-46C1A3067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3E61E2-8D90-0046-9C62-85D66D5BD7FF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8BBB5AEC-6988-A1BB-F805-815C79B2A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522746B3-4D62-5698-5340-DCF26429E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E9294B-B905-964E-8FF9-6EB43287405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41651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3">
            <a:extLst>
              <a:ext uri="{FF2B5EF4-FFF2-40B4-BE49-F238E27FC236}">
                <a16:creationId xmlns:a16="http://schemas.microsoft.com/office/drawing/2014/main" id="{5D639FB5-1014-076A-E9DF-EE59607034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AE1678-F403-074A-9632-57208D08ABC9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6" name="フッター プレースホルダ 4">
            <a:extLst>
              <a:ext uri="{FF2B5EF4-FFF2-40B4-BE49-F238E27FC236}">
                <a16:creationId xmlns:a16="http://schemas.microsoft.com/office/drawing/2014/main" id="{CE949AF2-9189-22C4-DF26-260D0B689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>
            <a:extLst>
              <a:ext uri="{FF2B5EF4-FFF2-40B4-BE49-F238E27FC236}">
                <a16:creationId xmlns:a16="http://schemas.microsoft.com/office/drawing/2014/main" id="{0E169638-0494-5F1A-7DC6-68A144037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1D9894-C55E-194C-948A-508D78B6337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70551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5" indent="0">
              <a:buNone/>
              <a:defRPr sz="2000" b="1"/>
            </a:lvl2pPr>
            <a:lvl3pPr marL="914388" indent="0">
              <a:buNone/>
              <a:defRPr sz="1800" b="1"/>
            </a:lvl3pPr>
            <a:lvl4pPr marL="1371583" indent="0">
              <a:buNone/>
              <a:defRPr sz="1600" b="1"/>
            </a:lvl4pPr>
            <a:lvl5pPr marL="1828777" indent="0">
              <a:buNone/>
              <a:defRPr sz="1600" b="1"/>
            </a:lvl5pPr>
            <a:lvl6pPr marL="2285972" indent="0">
              <a:buNone/>
              <a:defRPr sz="1600" b="1"/>
            </a:lvl6pPr>
            <a:lvl7pPr marL="2743166" indent="0">
              <a:buNone/>
              <a:defRPr sz="1600" b="1"/>
            </a:lvl7pPr>
            <a:lvl8pPr marL="3200360" indent="0">
              <a:buNone/>
              <a:defRPr sz="1600" b="1"/>
            </a:lvl8pPr>
            <a:lvl9pPr marL="3657555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5" indent="0">
              <a:buNone/>
              <a:defRPr sz="2000" b="1"/>
            </a:lvl2pPr>
            <a:lvl3pPr marL="914388" indent="0">
              <a:buNone/>
              <a:defRPr sz="1800" b="1"/>
            </a:lvl3pPr>
            <a:lvl4pPr marL="1371583" indent="0">
              <a:buNone/>
              <a:defRPr sz="1600" b="1"/>
            </a:lvl4pPr>
            <a:lvl5pPr marL="1828777" indent="0">
              <a:buNone/>
              <a:defRPr sz="1600" b="1"/>
            </a:lvl5pPr>
            <a:lvl6pPr marL="2285972" indent="0">
              <a:buNone/>
              <a:defRPr sz="1600" b="1"/>
            </a:lvl6pPr>
            <a:lvl7pPr marL="2743166" indent="0">
              <a:buNone/>
              <a:defRPr sz="1600" b="1"/>
            </a:lvl7pPr>
            <a:lvl8pPr marL="3200360" indent="0">
              <a:buNone/>
              <a:defRPr sz="1600" b="1"/>
            </a:lvl8pPr>
            <a:lvl9pPr marL="3657555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3">
            <a:extLst>
              <a:ext uri="{FF2B5EF4-FFF2-40B4-BE49-F238E27FC236}">
                <a16:creationId xmlns:a16="http://schemas.microsoft.com/office/drawing/2014/main" id="{86BCB59B-B491-5051-F3C1-F3BD25D7D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294318-DAFA-164F-8D3F-2E93089E03FA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8" name="フッター プレースホルダ 4">
            <a:extLst>
              <a:ext uri="{FF2B5EF4-FFF2-40B4-BE49-F238E27FC236}">
                <a16:creationId xmlns:a16="http://schemas.microsoft.com/office/drawing/2014/main" id="{8667C343-118F-CF92-946E-B26CBE815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>
            <a:extLst>
              <a:ext uri="{FF2B5EF4-FFF2-40B4-BE49-F238E27FC236}">
                <a16:creationId xmlns:a16="http://schemas.microsoft.com/office/drawing/2014/main" id="{1A125EEC-9C0B-06B0-0D53-5C92F9F7F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946CE9-F982-C84A-9452-4B99EA40B60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8565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日付プレースホルダ 3">
            <a:extLst>
              <a:ext uri="{FF2B5EF4-FFF2-40B4-BE49-F238E27FC236}">
                <a16:creationId xmlns:a16="http://schemas.microsoft.com/office/drawing/2014/main" id="{BBD4E06E-7397-E0BB-75E0-BE865A8C7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DC5547-61FF-F046-BC39-13EA71213B2F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4" name="フッター プレースホルダ 4">
            <a:extLst>
              <a:ext uri="{FF2B5EF4-FFF2-40B4-BE49-F238E27FC236}">
                <a16:creationId xmlns:a16="http://schemas.microsoft.com/office/drawing/2014/main" id="{1E189DB8-7E3F-A96E-9613-3A9224EE1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>
            <a:extLst>
              <a:ext uri="{FF2B5EF4-FFF2-40B4-BE49-F238E27FC236}">
                <a16:creationId xmlns:a16="http://schemas.microsoft.com/office/drawing/2014/main" id="{883527B8-106A-BD71-D01C-3197990A3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E61411-3B0A-804F-A237-8088CEE6DDD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47315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>
            <a:extLst>
              <a:ext uri="{FF2B5EF4-FFF2-40B4-BE49-F238E27FC236}">
                <a16:creationId xmlns:a16="http://schemas.microsoft.com/office/drawing/2014/main" id="{A330AC4B-0CE8-FE95-08F4-46C88B9FC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43F6A2-7184-734D-B9C4-DAE20BEAA1D5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3" name="フッター プレースホルダ 4">
            <a:extLst>
              <a:ext uri="{FF2B5EF4-FFF2-40B4-BE49-F238E27FC236}">
                <a16:creationId xmlns:a16="http://schemas.microsoft.com/office/drawing/2014/main" id="{AA93849B-1675-B02A-5B52-F65C5531D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>
            <a:extLst>
              <a:ext uri="{FF2B5EF4-FFF2-40B4-BE49-F238E27FC236}">
                <a16:creationId xmlns:a16="http://schemas.microsoft.com/office/drawing/2014/main" id="{D0DAA1D7-7C28-0424-1BAC-52036B03E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5C4293-74A1-B142-9168-FA9923C4795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80616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95" indent="0">
              <a:buNone/>
              <a:defRPr sz="1200"/>
            </a:lvl2pPr>
            <a:lvl3pPr marL="914388" indent="0">
              <a:buNone/>
              <a:defRPr sz="1000"/>
            </a:lvl3pPr>
            <a:lvl4pPr marL="1371583" indent="0">
              <a:buNone/>
              <a:defRPr sz="900"/>
            </a:lvl4pPr>
            <a:lvl5pPr marL="1828777" indent="0">
              <a:buNone/>
              <a:defRPr sz="900"/>
            </a:lvl5pPr>
            <a:lvl6pPr marL="2285972" indent="0">
              <a:buNone/>
              <a:defRPr sz="900"/>
            </a:lvl6pPr>
            <a:lvl7pPr marL="2743166" indent="0">
              <a:buNone/>
              <a:defRPr sz="900"/>
            </a:lvl7pPr>
            <a:lvl8pPr marL="3200360" indent="0">
              <a:buNone/>
              <a:defRPr sz="900"/>
            </a:lvl8pPr>
            <a:lvl9pPr marL="3657555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3">
            <a:extLst>
              <a:ext uri="{FF2B5EF4-FFF2-40B4-BE49-F238E27FC236}">
                <a16:creationId xmlns:a16="http://schemas.microsoft.com/office/drawing/2014/main" id="{A959C441-62A5-407B-E881-AD1FB78E4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B284B2-508F-BF42-905E-4367DFC53460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6" name="フッター プレースホルダ 4">
            <a:extLst>
              <a:ext uri="{FF2B5EF4-FFF2-40B4-BE49-F238E27FC236}">
                <a16:creationId xmlns:a16="http://schemas.microsoft.com/office/drawing/2014/main" id="{012A4571-296D-5F77-53B3-0888AC3FE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>
            <a:extLst>
              <a:ext uri="{FF2B5EF4-FFF2-40B4-BE49-F238E27FC236}">
                <a16:creationId xmlns:a16="http://schemas.microsoft.com/office/drawing/2014/main" id="{B73EED42-5A17-82E5-0CEE-25F29CCAE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63E5D1-E7DC-CF45-9558-333BB9FBE7A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15916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3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95" indent="0">
              <a:buNone/>
              <a:defRPr sz="2800"/>
            </a:lvl2pPr>
            <a:lvl3pPr marL="914388" indent="0">
              <a:buNone/>
              <a:defRPr sz="2400"/>
            </a:lvl3pPr>
            <a:lvl4pPr marL="1371583" indent="0">
              <a:buNone/>
              <a:defRPr sz="2000"/>
            </a:lvl4pPr>
            <a:lvl5pPr marL="1828777" indent="0">
              <a:buNone/>
              <a:defRPr sz="2000"/>
            </a:lvl5pPr>
            <a:lvl6pPr marL="2285972" indent="0">
              <a:buNone/>
              <a:defRPr sz="2000"/>
            </a:lvl6pPr>
            <a:lvl7pPr marL="2743166" indent="0">
              <a:buNone/>
              <a:defRPr sz="2000"/>
            </a:lvl7pPr>
            <a:lvl8pPr marL="3200360" indent="0">
              <a:buNone/>
              <a:defRPr sz="2000"/>
            </a:lvl8pPr>
            <a:lvl9pPr marL="3657555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4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95" indent="0">
              <a:buNone/>
              <a:defRPr sz="1200"/>
            </a:lvl2pPr>
            <a:lvl3pPr marL="914388" indent="0">
              <a:buNone/>
              <a:defRPr sz="1000"/>
            </a:lvl3pPr>
            <a:lvl4pPr marL="1371583" indent="0">
              <a:buNone/>
              <a:defRPr sz="900"/>
            </a:lvl4pPr>
            <a:lvl5pPr marL="1828777" indent="0">
              <a:buNone/>
              <a:defRPr sz="900"/>
            </a:lvl5pPr>
            <a:lvl6pPr marL="2285972" indent="0">
              <a:buNone/>
              <a:defRPr sz="900"/>
            </a:lvl6pPr>
            <a:lvl7pPr marL="2743166" indent="0">
              <a:buNone/>
              <a:defRPr sz="900"/>
            </a:lvl7pPr>
            <a:lvl8pPr marL="3200360" indent="0">
              <a:buNone/>
              <a:defRPr sz="900"/>
            </a:lvl8pPr>
            <a:lvl9pPr marL="3657555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3">
            <a:extLst>
              <a:ext uri="{FF2B5EF4-FFF2-40B4-BE49-F238E27FC236}">
                <a16:creationId xmlns:a16="http://schemas.microsoft.com/office/drawing/2014/main" id="{82A25002-7B3D-071F-6920-D6D974A125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D8FE0C-5F06-0D43-8FB2-7504127C3D30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6" name="フッター プレースホルダ 4">
            <a:extLst>
              <a:ext uri="{FF2B5EF4-FFF2-40B4-BE49-F238E27FC236}">
                <a16:creationId xmlns:a16="http://schemas.microsoft.com/office/drawing/2014/main" id="{0460982A-0E58-CB13-225C-80C4247A8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>
            <a:extLst>
              <a:ext uri="{FF2B5EF4-FFF2-40B4-BE49-F238E27FC236}">
                <a16:creationId xmlns:a16="http://schemas.microsoft.com/office/drawing/2014/main" id="{64E053B0-7D22-1597-6D10-52C1FAF87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C48BA8-9CC2-3F48-9F8D-266D4E98111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02865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>
            <a:extLst>
              <a:ext uri="{FF2B5EF4-FFF2-40B4-BE49-F238E27FC236}">
                <a16:creationId xmlns:a16="http://schemas.microsoft.com/office/drawing/2014/main" id="{6DE55A09-E7DC-0AF0-A432-8BD256EFB390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>
            <a:extLst>
              <a:ext uri="{FF2B5EF4-FFF2-40B4-BE49-F238E27FC236}">
                <a16:creationId xmlns:a16="http://schemas.microsoft.com/office/drawing/2014/main" id="{6F2E14B2-F0ED-45DD-D694-3363FF9DA05D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29902961-74A6-F353-C29E-41A5FFA38E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5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C4936C8-81A4-444C-B1F0-B5A755A2B6A1}" type="datetimeFigureOut">
              <a:rPr lang="ja-JP" altLang="en-US"/>
              <a:pPr>
                <a:defRPr/>
              </a:pPr>
              <a:t>2024/10/26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F9D94E9E-E96D-F0B0-D120-27CAA50A0F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5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3A097B48-00FD-C522-AD5A-EC4206B122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5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DDAD5F6A-4828-D449-9539-182F617FB66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panose="020B0600070205080204" pitchFamily="34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5pPr>
      <a:lvl6pPr marL="457195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6pPr>
      <a:lvl7pPr marL="914388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7pPr>
      <a:lvl8pPr marL="1371583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8pPr>
      <a:lvl9pPr marL="1828777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9pPr>
    </p:titleStyle>
    <p:bodyStyle>
      <a:lvl1pPr marL="342891" indent="-342891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panose="020B0600070205080204" pitchFamily="34" charset="-128"/>
        </a:defRPr>
      </a:lvl1pPr>
      <a:lvl2pPr marL="742932" indent="-28574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ＭＳ Ｐゴシック" panose="020B0600070205080204" pitchFamily="34" charset="-128"/>
        </a:defRPr>
      </a:lvl2pPr>
      <a:lvl3pPr marL="1142971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panose="020B0600070205080204" pitchFamily="34" charset="-128"/>
        </a:defRPr>
      </a:lvl3pPr>
      <a:lvl4pPr marL="1600160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ＭＳ Ｐゴシック" panose="020B0600070205080204" pitchFamily="34" charset="-128"/>
        </a:defRPr>
      </a:lvl4pPr>
      <a:lvl5pPr marL="2057349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ＭＳ Ｐゴシック" panose="020B0600070205080204" pitchFamily="34" charset="-128"/>
        </a:defRPr>
      </a:lvl5pPr>
      <a:lvl6pPr marL="2514569" indent="-228597" algn="l" defTabSz="914388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63" indent="-228597" algn="l" defTabSz="914388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57" indent="-228597" algn="l" defTabSz="914388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51" indent="-228597" algn="l" defTabSz="914388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8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95" algn="l" defTabSz="91438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88" algn="l" defTabSz="91438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83" algn="l" defTabSz="91438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77" algn="l" defTabSz="91438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72" algn="l" defTabSz="91438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66" algn="l" defTabSz="91438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60" algn="l" defTabSz="91438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55" algn="l" defTabSz="914388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>
            <a:extLst>
              <a:ext uri="{FF2B5EF4-FFF2-40B4-BE49-F238E27FC236}">
                <a16:creationId xmlns:a16="http://schemas.microsoft.com/office/drawing/2014/main" id="{7CAB1B64-759E-389E-FFC5-AF5EE9DA62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025" y="4681769"/>
            <a:ext cx="3106633" cy="212040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6D517C85-1A7E-8034-7842-4A2A0159ED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3646" y="858796"/>
            <a:ext cx="3106633" cy="2120400"/>
          </a:xfrm>
          <a:prstGeom prst="rect">
            <a:avLst/>
          </a:prstGeom>
        </p:spPr>
      </p:pic>
      <p:sp>
        <p:nvSpPr>
          <p:cNvPr id="8197" name="テキスト ボックス 60">
            <a:extLst>
              <a:ext uri="{FF2B5EF4-FFF2-40B4-BE49-F238E27FC236}">
                <a16:creationId xmlns:a16="http://schemas.microsoft.com/office/drawing/2014/main" id="{E1ABB2BC-E630-EF0E-EB60-0C024CF698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4656" y="2339752"/>
            <a:ext cx="10652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0.0007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99" name="テキスト ボックス 62">
            <a:extLst>
              <a:ext uri="{FF2B5EF4-FFF2-40B4-BE49-F238E27FC236}">
                <a16:creationId xmlns:a16="http://schemas.microsoft.com/office/drawing/2014/main" id="{17551DB4-E68D-C4F7-493B-9F797BEF84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4269" y="2766370"/>
            <a:ext cx="30527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after surgery (Years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00" name="テキスト ボックス 63">
            <a:extLst>
              <a:ext uri="{FF2B5EF4-FFF2-40B4-BE49-F238E27FC236}">
                <a16:creationId xmlns:a16="http://schemas.microsoft.com/office/drawing/2014/main" id="{EFDF6C50-5357-7008-B56D-D851F9AA3170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600399" y="1599685"/>
            <a:ext cx="18478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isease-free survival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2">
            <a:extLst>
              <a:ext uri="{FF2B5EF4-FFF2-40B4-BE49-F238E27FC236}">
                <a16:creationId xmlns:a16="http://schemas.microsoft.com/office/drawing/2014/main" id="{0C9E46A8-A650-E1FE-223E-FBB0B2D1C9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278" y="98212"/>
            <a:ext cx="37395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65">
            <a:extLst>
              <a:ext uri="{FF2B5EF4-FFF2-40B4-BE49-F238E27FC236}">
                <a16:creationId xmlns:a16="http://schemas.microsoft.com/office/drawing/2014/main" id="{48A304F9-2947-4712-03AB-F298A0A2C5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527" y="2980273"/>
            <a:ext cx="3969569" cy="138499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None </a:t>
            </a:r>
          </a:p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280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204       124       60       21       13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Radiotherapy/Chemoradiotherapy (RT/CRT)</a:t>
            </a:r>
          </a:p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244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175       135       82       51       31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Chemotherapy</a:t>
            </a:r>
          </a:p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  8         3            2         2</a:t>
            </a:r>
          </a:p>
        </p:txBody>
      </p:sp>
      <p:sp>
        <p:nvSpPr>
          <p:cNvPr id="7" name="テキスト ボックス 59">
            <a:extLst>
              <a:ext uri="{FF2B5EF4-FFF2-40B4-BE49-F238E27FC236}">
                <a16:creationId xmlns:a16="http://schemas.microsoft.com/office/drawing/2014/main" id="{39EE6B62-4F60-12B5-C906-61C44E1E31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15246" y="974461"/>
            <a:ext cx="132815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None</a:t>
            </a:r>
          </a:p>
        </p:txBody>
      </p:sp>
      <p:sp>
        <p:nvSpPr>
          <p:cNvPr id="8" name="テキスト ボックス 61">
            <a:extLst>
              <a:ext uri="{FF2B5EF4-FFF2-40B4-BE49-F238E27FC236}">
                <a16:creationId xmlns:a16="http://schemas.microsoft.com/office/drawing/2014/main" id="{409DC43F-FD85-B3F5-E225-A35F68538E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8356" y="2267325"/>
            <a:ext cx="12570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Chemotherapy</a:t>
            </a:r>
          </a:p>
        </p:txBody>
      </p:sp>
      <p:sp>
        <p:nvSpPr>
          <p:cNvPr id="3" name="テキスト ボックス 59">
            <a:extLst>
              <a:ext uri="{FF2B5EF4-FFF2-40B4-BE49-F238E27FC236}">
                <a16:creationId xmlns:a16="http://schemas.microsoft.com/office/drawing/2014/main" id="{AB86A0F7-E810-44BC-8669-0F29913099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640" y="482162"/>
            <a:ext cx="396956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4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A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isease-free survival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59">
            <a:extLst>
              <a:ext uri="{FF2B5EF4-FFF2-40B4-BE49-F238E27FC236}">
                <a16:creationId xmlns:a16="http://schemas.microsoft.com/office/drawing/2014/main" id="{9A34C84D-2CB7-27DC-9231-EA27169E56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5026" y="4383001"/>
            <a:ext cx="410806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B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60">
            <a:extLst>
              <a:ext uri="{FF2B5EF4-FFF2-40B4-BE49-F238E27FC236}">
                <a16:creationId xmlns:a16="http://schemas.microsoft.com/office/drawing/2014/main" id="{BE938535-F98A-155D-B9F7-BB785D1CE5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4656" y="6187040"/>
            <a:ext cx="10652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0.024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62">
            <a:extLst>
              <a:ext uri="{FF2B5EF4-FFF2-40B4-BE49-F238E27FC236}">
                <a16:creationId xmlns:a16="http://schemas.microsoft.com/office/drawing/2014/main" id="{91BA71ED-31EE-6089-7F62-D696B7B3FB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4269" y="6613608"/>
            <a:ext cx="30527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after surgery (Years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63">
            <a:extLst>
              <a:ext uri="{FF2B5EF4-FFF2-40B4-BE49-F238E27FC236}">
                <a16:creationId xmlns:a16="http://schemas.microsoft.com/office/drawing/2014/main" id="{ADE1930B-5824-8715-A90D-05A1B0639D0B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600399" y="5446923"/>
            <a:ext cx="18478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65">
            <a:extLst>
              <a:ext uri="{FF2B5EF4-FFF2-40B4-BE49-F238E27FC236}">
                <a16:creationId xmlns:a16="http://schemas.microsoft.com/office/drawing/2014/main" id="{727DAC75-199B-2416-3A70-FC36E88C7F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648" y="6840414"/>
            <a:ext cx="3969569" cy="138499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None</a:t>
            </a:r>
          </a:p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280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250       166       82       31       16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Radiotherapy/Chemoradiotherapy (RT/CRT)</a:t>
            </a:r>
          </a:p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244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230       174      113       71       42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Chemotherapy</a:t>
            </a:r>
          </a:p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  8         8            4         3</a:t>
            </a:r>
          </a:p>
        </p:txBody>
      </p:sp>
      <p:sp>
        <p:nvSpPr>
          <p:cNvPr id="9" name="テキスト ボックス 59">
            <a:extLst>
              <a:ext uri="{FF2B5EF4-FFF2-40B4-BE49-F238E27FC236}">
                <a16:creationId xmlns:a16="http://schemas.microsoft.com/office/drawing/2014/main" id="{D03035F8-5064-82DE-713A-F23C3B2E91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46715" y="1548109"/>
            <a:ext cx="10652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RT/CRT</a:t>
            </a:r>
          </a:p>
        </p:txBody>
      </p:sp>
      <p:sp>
        <p:nvSpPr>
          <p:cNvPr id="18" name="テキスト ボックス 59">
            <a:extLst>
              <a:ext uri="{FF2B5EF4-FFF2-40B4-BE49-F238E27FC236}">
                <a16:creationId xmlns:a16="http://schemas.microsoft.com/office/drawing/2014/main" id="{0C705581-E461-4F7A-3646-D9A88D1F3D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08761" y="4543270"/>
            <a:ext cx="132815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None</a:t>
            </a:r>
          </a:p>
        </p:txBody>
      </p:sp>
      <p:sp>
        <p:nvSpPr>
          <p:cNvPr id="19" name="テキスト ボックス 61">
            <a:extLst>
              <a:ext uri="{FF2B5EF4-FFF2-40B4-BE49-F238E27FC236}">
                <a16:creationId xmlns:a16="http://schemas.microsoft.com/office/drawing/2014/main" id="{E2AAFB90-7CFC-307D-6E7C-4E44DF34D2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8955" y="5119037"/>
            <a:ext cx="12570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Chemotherapy</a:t>
            </a:r>
          </a:p>
        </p:txBody>
      </p:sp>
      <p:sp>
        <p:nvSpPr>
          <p:cNvPr id="20" name="テキスト ボックス 59">
            <a:extLst>
              <a:ext uri="{FF2B5EF4-FFF2-40B4-BE49-F238E27FC236}">
                <a16:creationId xmlns:a16="http://schemas.microsoft.com/office/drawing/2014/main" id="{7905001E-7EFD-AF4D-9474-D725E206F7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15240" y="5229891"/>
            <a:ext cx="77462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RT/CRT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F98FCA2-45D8-0872-57D1-3930766D5F89}"/>
              </a:ext>
            </a:extLst>
          </p:cNvPr>
          <p:cNvSpPr txBox="1"/>
          <p:nvPr/>
        </p:nvSpPr>
        <p:spPr>
          <a:xfrm>
            <a:off x="185025" y="8225409"/>
            <a:ext cx="626831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  <a:p>
            <a:r>
              <a:rPr kumimoji="1"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lationships between the preoperative treatment strategies and disease-free survival (DFS) and overall survival (OS). Kaplan-Meier DFS (A) and OS (B) were stratified according to the preoperative treatment strategies.</a:t>
            </a:r>
          </a:p>
        </p:txBody>
      </p:sp>
    </p:spTree>
    <p:extLst>
      <p:ext uri="{BB962C8B-B14F-4D97-AF65-F5344CB8AC3E}">
        <p14:creationId xmlns:p14="http://schemas.microsoft.com/office/powerpoint/2010/main" val="2476246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530</TotalTime>
  <Words>145</Words>
  <Application>Microsoft Macintosh PowerPoint</Application>
  <PresentationFormat>画面に合わせる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ya abe</dc:creator>
  <cp:lastModifiedBy>Shinya Abe</cp:lastModifiedBy>
  <cp:revision>172</cp:revision>
  <dcterms:created xsi:type="dcterms:W3CDTF">2016-12-27T14:31:57Z</dcterms:created>
  <dcterms:modified xsi:type="dcterms:W3CDTF">2024-10-25T19:30:50Z</dcterms:modified>
</cp:coreProperties>
</file>